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6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0"/>
  </p:normalViewPr>
  <p:slideViewPr>
    <p:cSldViewPr snapToGrid="0" snapToObjects="1">
      <p:cViewPr varScale="1">
        <p:scale>
          <a:sx n="83" d="100"/>
          <a:sy n="83" d="100"/>
        </p:scale>
        <p:origin x="65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769287-FF8C-6940-BBB3-FDBD70EB9AA2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ACB0B8-319E-A148-B6CC-873596BC2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076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BD27FF-F185-8443-818D-E407CD9E301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2228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176444-9D64-5146-8E73-C22700E627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2A8B4A-D71F-F645-B1F8-CEE250034B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BF5C1-EF4D-D34D-A6C8-BC9EF4E98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6A283B-E0A2-8F41-95DB-227B78B35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2F3383-49E2-4F43-9500-FDA539A9A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495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25588-CD58-7E48-8F96-219DF03BFB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4E070F-D4B1-3E4E-81AD-7FB596AB82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5D8362-1FCF-AA45-A600-9486D868F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0CEB0D-0F62-4445-A3EC-9D6586A40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1ED3E-6342-CA42-8CEA-958140A8E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564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7D3DFC-CC08-7945-AE8C-35B3E74834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5517AF-FB70-094F-B0ED-B92149D577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C4ED0D-90D0-094B-B783-24D42E0106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F9B1E4-4E16-9447-9AA7-88D839768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4960A-6099-E84E-8B0E-08C804FD6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622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1F3F9-2A38-CC49-B4E8-A43ACEE2D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EBE4FD-8127-4F40-A598-94DB617245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60668-11E9-2A4E-944E-77F65E40B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05D777-978D-C94C-A77D-79467549A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85AD8B-A669-E54A-9DAC-5209715D7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643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0476B-A40B-9A46-9CF9-902A2FB50E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3BD7BF-316F-AE4A-B472-36EC63C8EF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3769DE-118B-F144-9F3B-AED17E62A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BE4AC9-5DC9-7140-8524-4D95BBD60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021F97-DCD6-594D-8FC6-6639298EC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42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8E25C-76F1-9748-8533-11B5A96CF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D9FEA6-1511-A842-A7F3-82D39F8005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C90FD7-11BA-AC4A-BFB3-694018DEDA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F8C2D7-9821-6044-B8BD-B49A3A8E7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26167B-DE9C-2B4D-9BDA-44CDA31CC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4146F-89D8-2747-B5C4-FFC2B7249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10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7AE629-82FB-3441-825A-DACF33DED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486B7B-5196-234D-B725-CBE1F3F29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E59496-6CA2-8F44-8A26-F84F06A79B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7A9262-D4A8-924E-BA0F-6BADEE010E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7A71A4-54AA-674D-BF64-9753E16AEC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8981C8-08CF-0B47-B318-7C3DC6A67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77AE54-3DF1-1E43-928D-A6775C94E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2F2433-3F0A-9F4B-83F2-23D55A878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685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C04B9-2EA9-E24E-9A8F-11CD563DE6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70CF0B-1302-1444-9E63-B1A49887F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536D4A-AC7B-B14B-8EC5-8FB7E1E9B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08BDD8-D4C2-854E-A512-6AC3C7C0C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256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9FE455-A0BF-D24B-ACD7-CD4E54E27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306756-84E3-B94D-ABCD-87FE5BA7A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DA9D20-DCF7-8B42-8E4A-38D4F5D1D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41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5E261-3B57-F743-9B01-E977153C87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1F72CC-CC7D-D34F-93CD-71AED99262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A55E9-C8A2-5648-883F-AD890C913F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F68AB8-DF3D-8F44-ACAB-B3225A6DB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96E920-0FFB-3445-B11D-F50F6F42E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A7329D-D2C4-AC45-B9F2-A59760CD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22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F834D-405A-5E42-BCAD-703C96B9E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84A12C-953D-6243-B429-E3343618E7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1282FC-F219-0146-B400-82110B6C43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982F92-AF09-7D49-8689-0FFC06933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689969-E55B-AC41-A8B9-E74F23A37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AF567A-2C2E-1C4B-9B8F-50DA17D0D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913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666340-5A0C-9947-9573-727E37F0F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CB231F-44B2-C140-B23A-A5E856C37F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F48A73-81A7-CB49-B406-058E171540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50D0-C361-1F45-B7EF-897F92FF872D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89CD61-D4C9-FC46-A7B8-05DA62E21A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06D14C-4DC9-6043-8B29-E98F0B4B53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F7F56-B42E-864D-8F16-310D5018E0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732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07A8F69-EE2A-C64E-85C2-D94FA916742C}"/>
              </a:ext>
            </a:extLst>
          </p:cNvPr>
          <p:cNvSpPr txBox="1"/>
          <p:nvPr/>
        </p:nvSpPr>
        <p:spPr>
          <a:xfrm>
            <a:off x="1014252" y="332347"/>
            <a:ext cx="65293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B0AB86B-500C-D346-93E6-5A8A9A4170E0}"/>
              </a:ext>
            </a:extLst>
          </p:cNvPr>
          <p:cNvSpPr/>
          <p:nvPr/>
        </p:nvSpPr>
        <p:spPr>
          <a:xfrm>
            <a:off x="574044" y="2103192"/>
            <a:ext cx="11328718" cy="8881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11113">
              <a:lnSpc>
                <a:spcPct val="200000"/>
              </a:lnSpc>
            </a:pP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opheles gambiae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s gonotrophic status per day of mosquito catch (a) in both VK3 and VK5 villages and (b) summary of catches over the study period 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3886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CC8A097-E24F-0D48-BA2B-97C309E318DB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0"/>
            <a:ext cx="5481320" cy="408495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A150FF0-8869-5C44-9B27-DE59459699C7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951" y="229869"/>
            <a:ext cx="5481320" cy="408495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16A08F9-8979-EB4B-8A34-B3A184BF42EB}"/>
              </a:ext>
            </a:extLst>
          </p:cNvPr>
          <p:cNvSpPr/>
          <p:nvPr/>
        </p:nvSpPr>
        <p:spPr>
          <a:xfrm>
            <a:off x="0" y="4700588"/>
            <a:ext cx="12077205" cy="8882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353060">
              <a:lnSpc>
                <a:spcPct val="200000"/>
              </a:lnSpc>
              <a:spcBef>
                <a:spcPts val="1000"/>
              </a:spcBef>
            </a:pPr>
            <a:r>
              <a:rPr lang="en-US" sz="1400" b="1" dirty="0">
                <a:solidFill>
                  <a:srgbClr val="243F6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400" dirty="0">
                <a:solidFill>
                  <a:srgbClr val="243F6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pheles gambiae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emales gonotrophic status per day of mosquito catch (a) in both VK3 and VK5 villages and (b) summary of catches according to the feeding status over the study period </a:t>
            </a:r>
            <a:endParaRPr lang="en-GB" sz="1400" dirty="0">
              <a:latin typeface="Cambria" panose="0204050305040603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0D00CF-1DA2-D34E-9617-D2680C328255}"/>
              </a:ext>
            </a:extLst>
          </p:cNvPr>
          <p:cNvSpPr txBox="1"/>
          <p:nvPr/>
        </p:nvSpPr>
        <p:spPr>
          <a:xfrm>
            <a:off x="2357438" y="433125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791C71-AC2F-8043-BFB9-12625F03F057}"/>
              </a:ext>
            </a:extLst>
          </p:cNvPr>
          <p:cNvSpPr txBox="1"/>
          <p:nvPr/>
        </p:nvSpPr>
        <p:spPr>
          <a:xfrm>
            <a:off x="8779829" y="431482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36150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Widescreen</PresentationFormat>
  <Paragraphs>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24</cp:revision>
  <dcterms:created xsi:type="dcterms:W3CDTF">2021-08-23T21:01:18Z</dcterms:created>
  <dcterms:modified xsi:type="dcterms:W3CDTF">2025-02-07T08:45:11Z</dcterms:modified>
</cp:coreProperties>
</file>